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8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F5022-E141-4EB5-8BB1-41FB5781CABB}" type="datetimeFigureOut">
              <a:rPr lang="en-US" smtClean="0"/>
              <a:pPr/>
              <a:t>4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3C25B-6ADB-44B8-A444-7133C3427C5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914400" y="16002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43800" y="762000"/>
            <a:ext cx="16002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762000"/>
            <a:ext cx="1552575" cy="4581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19800" y="762000"/>
            <a:ext cx="1524000" cy="4581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905125" y="762000"/>
            <a:ext cx="1743075" cy="4610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591050" y="762000"/>
            <a:ext cx="142875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524000" y="762000"/>
            <a:ext cx="1400175" cy="459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6" name="Rectangle 15"/>
          <p:cNvSpPr/>
          <p:nvPr/>
        </p:nvSpPr>
        <p:spPr>
          <a:xfrm>
            <a:off x="0" y="5257800"/>
            <a:ext cx="9144000" cy="2286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609600" y="5257800"/>
            <a:ext cx="8305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/>
              <a:t>0	      1	                2	            3	       4	                  5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23</Words>
  <Application>Microsoft Office PowerPoint</Application>
  <PresentationFormat>On-screen Show (4:3)</PresentationFormat>
  <Paragraphs>1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8</cp:revision>
  <dcterms:created xsi:type="dcterms:W3CDTF">2011-02-17T04:34:26Z</dcterms:created>
  <dcterms:modified xsi:type="dcterms:W3CDTF">2013-04-29T06:21:26Z</dcterms:modified>
</cp:coreProperties>
</file>